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976"/>
    <p:restoredTop sz="96327"/>
  </p:normalViewPr>
  <p:slideViewPr>
    <p:cSldViewPr snapToGrid="0">
      <p:cViewPr>
        <p:scale>
          <a:sx n="147" d="100"/>
          <a:sy n="147" d="100"/>
        </p:scale>
        <p:origin x="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30AE0E-843B-E4A2-18E5-C37CA56DA6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8055A9-14AC-595D-79FB-2678A5C8D0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6CE537-5423-BFDA-D0A1-1F1A23532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42FDD-8301-9C6F-041B-87C8BDA12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C9816F-42FA-28C6-584B-72F5E2F7F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79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BC50A-35D3-AE6C-DD1B-F55A8AAAF9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B33F67-CF4E-2A86-096C-DCEB819326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C5547B-9A35-7A6B-3D5E-C07AF44F3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0315C-99E7-832E-05EA-AA3D8887D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37081-55D8-B966-043D-BA39F8263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784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D7E2F3-17C8-4B8F-75D5-75D7756C68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87122C-96C0-6115-F8A1-D52802BE2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271493-5403-0AEB-3BC4-0AA43A510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86A87F-5853-0B32-8B7E-1CDD77681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E19CCA-2090-003C-B627-B60A0991D3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204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D5449-EE9F-0BE5-4106-71C7645ED6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BCA31D-4E55-D58C-8B0A-97A132AA26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3A9BCF-B75B-3982-6C9A-65CD2AB96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18CFC-57BC-56C1-5A5B-B8F961506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62615-676F-B63C-7CCC-E5E95A8D2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62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EDBB6-474B-6DCC-27B9-C02D6E885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2B6942-9887-64EE-7CA6-D17D58579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15CEA5-643B-6F3A-A0AA-2D13F5C83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911FCF-BA24-1D36-50AC-B256F8B31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5A28B-0784-5DED-B058-7DE217211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21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1925F-57FD-58B7-4BEA-B2A2252B1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70830-0F35-937D-9B50-53EE64F340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374B67-76B9-B5E1-3C2F-5AAEC937ED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853236-9064-1EF0-D846-742E9CAA8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74CBBE-5120-914A-CD8A-E0032AE4B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E02DE7-64A3-3677-F567-FDD0067AB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811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83725-FF84-EF4F-94D4-BE1234291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909013-A947-0CDD-8A9F-C3ECA0307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C87B19-E21B-3608-1BF1-8E298147BE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226874-A484-265D-6E08-270742ED96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6EC39E-3628-D6CC-9A38-39069B469B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9BEEEA-547F-92CF-85C8-A2C7B5394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F155FD-D8CD-58D3-6E7D-155735707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02BA80-DABA-9E99-ABCA-35FFDAD5B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473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544C4-6734-B6E8-AA5F-934C7FA08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C3CDEE-0D8B-63AF-6552-D5B569AFC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26A062-AD85-8131-0418-45DD8F298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99059F-363B-5CE2-B6CE-CB6FF5FB6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066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E34357-A521-1D28-AE66-7394B97E4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DFE8D4-8993-66F4-5A15-1F9207F5F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000F52-CBFE-4ECA-D9E0-8926B3835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98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CB2369-0400-4F9A-026C-B3DCBAF05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5BB9FB-6919-D9E6-8BA4-A90133D4A0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3BD00B-F981-1471-E2C7-3476D15703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42B730-2596-15CD-FEDE-B44C52DDE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8CCA1D-ADAD-12F0-41E1-9448A26B4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FE8C6E-70BF-3BFD-B561-5B2934456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4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08FE1-E52B-FF36-E39F-A57EDACD5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3DDB93-94ED-75DF-0165-8507292D49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7D3005-16A8-657A-8EF2-BEB0D7FAB9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3DC53C-FB50-52D5-B4A9-ABCCAB325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0DF400-0CE5-D154-8D74-E30DFB123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B25B06-A9CE-2ECC-A7B4-AE043AFCE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152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B8F3BC-5F1C-B295-0744-C9C963282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FA51E3-ACE3-D4A7-33FD-F8A73D0EE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A834D9-EC9D-2D29-5E7A-D5915BBFF4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C2DBB-DB62-4F40-B8B8-382E80F356DD}" type="datetimeFigureOut">
              <a:rPr lang="en-US" smtClean="0"/>
              <a:t>9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7FE46E-8A97-DFE6-0D53-F198B9753F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FC150-F9F9-C4DA-901A-E74B6F1A3D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1B1AE-0EE2-E340-9664-E9D75F908A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645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0EE5CA4-BEFA-B96B-8249-06203DB92F02}"/>
              </a:ext>
            </a:extLst>
          </p:cNvPr>
          <p:cNvSpPr txBox="1"/>
          <p:nvPr/>
        </p:nvSpPr>
        <p:spPr>
          <a:xfrm>
            <a:off x="2842463" y="724644"/>
            <a:ext cx="1604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IF14 (190kD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01BB95E-E57A-09BB-B012-88F14789C4A2}"/>
              </a:ext>
            </a:extLst>
          </p:cNvPr>
          <p:cNvSpPr txBox="1"/>
          <p:nvPr/>
        </p:nvSpPr>
        <p:spPr>
          <a:xfrm>
            <a:off x="6288688" y="803267"/>
            <a:ext cx="1571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NMD (37kD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96FA2F-BC74-3B4F-2A7A-4B11DAC179A7}"/>
              </a:ext>
            </a:extLst>
          </p:cNvPr>
          <p:cNvSpPr txBox="1"/>
          <p:nvPr/>
        </p:nvSpPr>
        <p:spPr>
          <a:xfrm>
            <a:off x="3407465" y="3048538"/>
            <a:ext cx="2079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THFD1L (106 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AA5A874-8EEB-C681-AE00-AA2D711ACAAD}"/>
              </a:ext>
            </a:extLst>
          </p:cNvPr>
          <p:cNvSpPr txBox="1"/>
          <p:nvPr/>
        </p:nvSpPr>
        <p:spPr>
          <a:xfrm>
            <a:off x="6061282" y="3114120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42kDa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93A261D-9259-7051-DE06-B339606823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3070440" y="3504901"/>
            <a:ext cx="2638032" cy="196093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6949E52B-5B59-6EB4-8854-D9A848F4207D}"/>
              </a:ext>
            </a:extLst>
          </p:cNvPr>
          <p:cNvSpPr txBox="1"/>
          <p:nvPr/>
        </p:nvSpPr>
        <p:spPr>
          <a:xfrm>
            <a:off x="2270550" y="4659158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803A6A3-3EF5-BD34-F7AF-734501BF8053}"/>
              </a:ext>
            </a:extLst>
          </p:cNvPr>
          <p:cNvSpPr txBox="1"/>
          <p:nvPr/>
        </p:nvSpPr>
        <p:spPr>
          <a:xfrm>
            <a:off x="2274130" y="4292887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3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35D1FE5-994E-68F9-85CD-A902B324DFB1}"/>
              </a:ext>
            </a:extLst>
          </p:cNvPr>
          <p:cNvSpPr txBox="1"/>
          <p:nvPr/>
        </p:nvSpPr>
        <p:spPr>
          <a:xfrm>
            <a:off x="1442831" y="255110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0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9DB2C43-4F82-89B8-CD1C-C56DA2EDBC70}"/>
              </a:ext>
            </a:extLst>
          </p:cNvPr>
          <p:cNvSpPr txBox="1"/>
          <p:nvPr/>
        </p:nvSpPr>
        <p:spPr>
          <a:xfrm>
            <a:off x="1403557" y="2049169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01F1DD1-8A41-35C5-5AAA-273D24D6139E}"/>
              </a:ext>
            </a:extLst>
          </p:cNvPr>
          <p:cNvSpPr txBox="1"/>
          <p:nvPr/>
        </p:nvSpPr>
        <p:spPr>
          <a:xfrm>
            <a:off x="1403557" y="1810622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30kD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DA0C855-7048-3B6B-BF30-8DB30B7677BC}"/>
              </a:ext>
            </a:extLst>
          </p:cNvPr>
          <p:cNvSpPr txBox="1"/>
          <p:nvPr/>
        </p:nvSpPr>
        <p:spPr>
          <a:xfrm>
            <a:off x="2270551" y="3957605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D053A5-E184-7A8E-25E7-8E6CD9B976A2}"/>
              </a:ext>
            </a:extLst>
          </p:cNvPr>
          <p:cNvSpPr txBox="1"/>
          <p:nvPr/>
        </p:nvSpPr>
        <p:spPr>
          <a:xfrm>
            <a:off x="1425513" y="1487457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kDa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2AB76B92-3DFD-E361-F600-7354105B224C}"/>
              </a:ext>
            </a:extLst>
          </p:cNvPr>
          <p:cNvCxnSpPr/>
          <p:nvPr/>
        </p:nvCxnSpPr>
        <p:spPr>
          <a:xfrm>
            <a:off x="2000437" y="1625053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0759EA4-5110-D7BA-22E8-1C86FDFA8C66}"/>
              </a:ext>
            </a:extLst>
          </p:cNvPr>
          <p:cNvCxnSpPr/>
          <p:nvPr/>
        </p:nvCxnSpPr>
        <p:spPr>
          <a:xfrm>
            <a:off x="1984023" y="1960335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FB92FAE-7368-1821-D329-4F4ED1952DFB}"/>
              </a:ext>
            </a:extLst>
          </p:cNvPr>
          <p:cNvCxnSpPr/>
          <p:nvPr/>
        </p:nvCxnSpPr>
        <p:spPr>
          <a:xfrm>
            <a:off x="1981676" y="2183073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A7782419-54A5-6EF5-F3FF-C70F0DBEFA81}"/>
              </a:ext>
            </a:extLst>
          </p:cNvPr>
          <p:cNvCxnSpPr/>
          <p:nvPr/>
        </p:nvCxnSpPr>
        <p:spPr>
          <a:xfrm>
            <a:off x="1965264" y="2715300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32A46978-AC7D-83B0-0285-F024FC801F95}"/>
              </a:ext>
            </a:extLst>
          </p:cNvPr>
          <p:cNvCxnSpPr/>
          <p:nvPr/>
        </p:nvCxnSpPr>
        <p:spPr>
          <a:xfrm>
            <a:off x="2857241" y="4119356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5F9A2EE-B3FD-97E9-ABF0-38F2242B9963}"/>
              </a:ext>
            </a:extLst>
          </p:cNvPr>
          <p:cNvCxnSpPr/>
          <p:nvPr/>
        </p:nvCxnSpPr>
        <p:spPr>
          <a:xfrm>
            <a:off x="2868743" y="4440570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B3DEC5A-ABCD-0109-CA14-3B18194CE04D}"/>
              </a:ext>
            </a:extLst>
          </p:cNvPr>
          <p:cNvCxnSpPr/>
          <p:nvPr/>
        </p:nvCxnSpPr>
        <p:spPr>
          <a:xfrm>
            <a:off x="2866396" y="4803988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Picture 34">
            <a:extLst>
              <a:ext uri="{FF2B5EF4-FFF2-40B4-BE49-F238E27FC236}">
                <a16:creationId xmlns:a16="http://schemas.microsoft.com/office/drawing/2014/main" id="{45648097-AFA7-1EE3-CD99-252CA26A279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5171" b="11612"/>
          <a:stretch/>
        </p:blipFill>
        <p:spPr>
          <a:xfrm>
            <a:off x="5922806" y="3624891"/>
            <a:ext cx="1729594" cy="1840947"/>
          </a:xfrm>
          <a:prstGeom prst="rect">
            <a:avLst/>
          </a:prstGeom>
        </p:spPr>
      </p:pic>
      <p:graphicFrame>
        <p:nvGraphicFramePr>
          <p:cNvPr id="36" name="Table 35">
            <a:extLst>
              <a:ext uri="{FF2B5EF4-FFF2-40B4-BE49-F238E27FC236}">
                <a16:creationId xmlns:a16="http://schemas.microsoft.com/office/drawing/2014/main" id="{AEBB1F1B-2261-625C-AB95-AB71597D33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4377024"/>
              </p:ext>
            </p:extLst>
          </p:nvPr>
        </p:nvGraphicFramePr>
        <p:xfrm>
          <a:off x="1183108" y="5606080"/>
          <a:ext cx="8255000" cy="812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500">
                  <a:extLst>
                    <a:ext uri="{9D8B030D-6E8A-4147-A177-3AD203B41FA5}">
                      <a16:colId xmlns:a16="http://schemas.microsoft.com/office/drawing/2014/main" val="126120110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4204750595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400576119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56034655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366167258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57088275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608406078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89548462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29273843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426699398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KIF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NM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THFD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26463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ME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.042348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.959942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.415773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.5160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109292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477968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000302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.745247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.130517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284830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TMB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280836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.010857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426161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.373088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.898182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.171481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.467536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.493376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.627004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719223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-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.649405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576045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097496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.547334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.095845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.972346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129369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.35354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8.827907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59218274"/>
                  </a:ext>
                </a:extLst>
              </a:tr>
            </a:tbl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DF4BE30F-7209-85F7-7C1D-44470CB26564}"/>
              </a:ext>
            </a:extLst>
          </p:cNvPr>
          <p:cNvSpPr txBox="1"/>
          <p:nvPr/>
        </p:nvSpPr>
        <p:spPr>
          <a:xfrm>
            <a:off x="1096285" y="6406526"/>
            <a:ext cx="20348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ensitometry (protein/actin)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E767F8B2-2721-C070-DD0C-1075CED40E5A}"/>
              </a:ext>
            </a:extLst>
          </p:cNvPr>
          <p:cNvCxnSpPr>
            <a:cxnSpLocks/>
          </p:cNvCxnSpPr>
          <p:nvPr/>
        </p:nvCxnSpPr>
        <p:spPr>
          <a:xfrm flipH="1">
            <a:off x="7652400" y="4309621"/>
            <a:ext cx="17618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74AE0BC-B21A-C9CC-6A24-EA2CBFA387A1}"/>
              </a:ext>
            </a:extLst>
          </p:cNvPr>
          <p:cNvCxnSpPr>
            <a:cxnSpLocks/>
          </p:cNvCxnSpPr>
          <p:nvPr/>
        </p:nvCxnSpPr>
        <p:spPr>
          <a:xfrm flipH="1">
            <a:off x="7646967" y="4574014"/>
            <a:ext cx="1816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3D2A8F-E029-2B63-D9DC-5B76F5CA3B3D}"/>
              </a:ext>
            </a:extLst>
          </p:cNvPr>
          <p:cNvSpPr txBox="1"/>
          <p:nvPr/>
        </p:nvSpPr>
        <p:spPr>
          <a:xfrm>
            <a:off x="7760992" y="441514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5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09CB5DD-4222-8E95-EFBB-7624DEDBCB8C}"/>
              </a:ext>
            </a:extLst>
          </p:cNvPr>
          <p:cNvSpPr txBox="1"/>
          <p:nvPr/>
        </p:nvSpPr>
        <p:spPr>
          <a:xfrm>
            <a:off x="7782762" y="416217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5kDa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7E79C565-59A6-421F-378A-C43748B2F125}"/>
              </a:ext>
            </a:extLst>
          </p:cNvPr>
          <p:cNvCxnSpPr/>
          <p:nvPr/>
        </p:nvCxnSpPr>
        <p:spPr>
          <a:xfrm flipH="1">
            <a:off x="5487315" y="4569886"/>
            <a:ext cx="3962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D525C48C-C42C-DAA8-9E3D-5D6A63CDD1B0}"/>
              </a:ext>
            </a:extLst>
          </p:cNvPr>
          <p:cNvCxnSpPr>
            <a:cxnSpLocks/>
          </p:cNvCxnSpPr>
          <p:nvPr/>
        </p:nvCxnSpPr>
        <p:spPr>
          <a:xfrm flipH="1">
            <a:off x="7662066" y="4145546"/>
            <a:ext cx="17618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A80439C-89B9-8024-7E4E-31E3D9D8DE75}"/>
              </a:ext>
            </a:extLst>
          </p:cNvPr>
          <p:cNvSpPr txBox="1"/>
          <p:nvPr/>
        </p:nvSpPr>
        <p:spPr>
          <a:xfrm>
            <a:off x="7792428" y="399810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0kDa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2B37A845-1E49-AC52-7B4A-B0786E2C3D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32096" y="1306253"/>
            <a:ext cx="2806700" cy="1828800"/>
          </a:xfrm>
          <a:prstGeom prst="rect">
            <a:avLst/>
          </a:prstGeom>
        </p:spPr>
      </p:pic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6048602D-0D7F-15D7-E74F-6146720A8857}"/>
              </a:ext>
            </a:extLst>
          </p:cNvPr>
          <p:cNvCxnSpPr/>
          <p:nvPr/>
        </p:nvCxnSpPr>
        <p:spPr>
          <a:xfrm flipH="1">
            <a:off x="4524807" y="1812052"/>
            <a:ext cx="3962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B70E92D2-FCBC-3512-8770-2837289FA733}"/>
              </a:ext>
            </a:extLst>
          </p:cNvPr>
          <p:cNvCxnSpPr>
            <a:cxnSpLocks/>
          </p:cNvCxnSpPr>
          <p:nvPr/>
        </p:nvCxnSpPr>
        <p:spPr>
          <a:xfrm>
            <a:off x="5534922" y="1979954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82F24110-9D59-8558-A8AF-F67B09786AF3}"/>
              </a:ext>
            </a:extLst>
          </p:cNvPr>
          <p:cNvCxnSpPr>
            <a:cxnSpLocks/>
          </p:cNvCxnSpPr>
          <p:nvPr/>
        </p:nvCxnSpPr>
        <p:spPr>
          <a:xfrm>
            <a:off x="5534922" y="2168064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3905CB6A-67B4-0FED-052C-2A78A44A3508}"/>
              </a:ext>
            </a:extLst>
          </p:cNvPr>
          <p:cNvCxnSpPr>
            <a:cxnSpLocks/>
          </p:cNvCxnSpPr>
          <p:nvPr/>
        </p:nvCxnSpPr>
        <p:spPr>
          <a:xfrm>
            <a:off x="5534922" y="2496093"/>
            <a:ext cx="1969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A752B40D-F154-2373-53D4-22FE5BB1E323}"/>
              </a:ext>
            </a:extLst>
          </p:cNvPr>
          <p:cNvSpPr txBox="1"/>
          <p:nvPr/>
        </p:nvSpPr>
        <p:spPr>
          <a:xfrm>
            <a:off x="5026732" y="235072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kD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C0B3782-0FFE-B0D1-853D-A67048FB39B0}"/>
              </a:ext>
            </a:extLst>
          </p:cNvPr>
          <p:cNvSpPr txBox="1"/>
          <p:nvPr/>
        </p:nvSpPr>
        <p:spPr>
          <a:xfrm>
            <a:off x="5039105" y="202140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5kD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0935ABB-458E-6284-5625-87E47C42C473}"/>
              </a:ext>
            </a:extLst>
          </p:cNvPr>
          <p:cNvSpPr txBox="1"/>
          <p:nvPr/>
        </p:nvSpPr>
        <p:spPr>
          <a:xfrm>
            <a:off x="5032633" y="182510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5kDa</a:t>
            </a: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2BC99ACA-DFEB-A8DF-91F8-D8B1881445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85270" y="1521751"/>
            <a:ext cx="2578100" cy="1244600"/>
          </a:xfrm>
          <a:prstGeom prst="rect">
            <a:avLst/>
          </a:prstGeom>
        </p:spPr>
      </p:pic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08BC0A8-32D4-D8DF-4BF2-E500792FC1ED}"/>
              </a:ext>
            </a:extLst>
          </p:cNvPr>
          <p:cNvCxnSpPr/>
          <p:nvPr/>
        </p:nvCxnSpPr>
        <p:spPr>
          <a:xfrm flipH="1">
            <a:off x="7658673" y="2112798"/>
            <a:ext cx="3962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E358059C-A3F5-B965-8160-B23DBAFF8604}"/>
              </a:ext>
            </a:extLst>
          </p:cNvPr>
          <p:cNvCxnSpPr>
            <a:cxnSpLocks/>
          </p:cNvCxnSpPr>
          <p:nvPr/>
        </p:nvCxnSpPr>
        <p:spPr>
          <a:xfrm flipH="1">
            <a:off x="7411287" y="4364614"/>
            <a:ext cx="25077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A9B6AB72-53E8-A6A2-923F-5671589C796E}"/>
              </a:ext>
            </a:extLst>
          </p:cNvPr>
          <p:cNvSpPr txBox="1"/>
          <p:nvPr/>
        </p:nvSpPr>
        <p:spPr>
          <a:xfrm>
            <a:off x="2653924" y="1061615"/>
            <a:ext cx="55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MEC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040953E-FB78-F5BC-755D-3896A3046882}"/>
              </a:ext>
            </a:extLst>
          </p:cNvPr>
          <p:cNvSpPr txBox="1"/>
          <p:nvPr/>
        </p:nvSpPr>
        <p:spPr>
          <a:xfrm>
            <a:off x="3302941" y="1058746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MB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FD55409-F7B4-BE4E-AD41-3F7A85E7B521}"/>
              </a:ext>
            </a:extLst>
          </p:cNvPr>
          <p:cNvSpPr txBox="1"/>
          <p:nvPr/>
        </p:nvSpPr>
        <p:spPr>
          <a:xfrm>
            <a:off x="3906968" y="1066954"/>
            <a:ext cx="534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-26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B3B5A76-99D8-1AF3-0275-C3728DCBA742}"/>
              </a:ext>
            </a:extLst>
          </p:cNvPr>
          <p:cNvSpPr txBox="1"/>
          <p:nvPr/>
        </p:nvSpPr>
        <p:spPr>
          <a:xfrm>
            <a:off x="5975498" y="1291049"/>
            <a:ext cx="55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MEC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33A04AF-A72D-C77D-56C2-5D6C18C8371F}"/>
              </a:ext>
            </a:extLst>
          </p:cNvPr>
          <p:cNvSpPr txBox="1"/>
          <p:nvPr/>
        </p:nvSpPr>
        <p:spPr>
          <a:xfrm>
            <a:off x="6624515" y="1288180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MBC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ADC146D-1C12-90CC-74D3-07286803B6F0}"/>
              </a:ext>
            </a:extLst>
          </p:cNvPr>
          <p:cNvSpPr txBox="1"/>
          <p:nvPr/>
        </p:nvSpPr>
        <p:spPr>
          <a:xfrm>
            <a:off x="7228542" y="1296388"/>
            <a:ext cx="534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-26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96FC108-062B-B102-C985-F1630E6B5630}"/>
              </a:ext>
            </a:extLst>
          </p:cNvPr>
          <p:cNvSpPr txBox="1"/>
          <p:nvPr/>
        </p:nvSpPr>
        <p:spPr>
          <a:xfrm>
            <a:off x="3597508" y="3350761"/>
            <a:ext cx="55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MEC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3BA855-14B7-9CDE-FC09-018C412ECC97}"/>
              </a:ext>
            </a:extLst>
          </p:cNvPr>
          <p:cNvSpPr txBox="1"/>
          <p:nvPr/>
        </p:nvSpPr>
        <p:spPr>
          <a:xfrm>
            <a:off x="4246525" y="3347892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MBC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C077769-B291-5C2B-4425-542CC3CE5BA2}"/>
              </a:ext>
            </a:extLst>
          </p:cNvPr>
          <p:cNvSpPr txBox="1"/>
          <p:nvPr/>
        </p:nvSpPr>
        <p:spPr>
          <a:xfrm>
            <a:off x="4850552" y="3356100"/>
            <a:ext cx="534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-26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259E57A-04B2-98CC-6E0B-FD247CD70CEB}"/>
              </a:ext>
            </a:extLst>
          </p:cNvPr>
          <p:cNvSpPr txBox="1"/>
          <p:nvPr/>
        </p:nvSpPr>
        <p:spPr>
          <a:xfrm>
            <a:off x="5928034" y="3431199"/>
            <a:ext cx="55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ME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2F10555-CE1D-FD6C-9905-C08DDF1668F9}"/>
              </a:ext>
            </a:extLst>
          </p:cNvPr>
          <p:cNvSpPr txBox="1"/>
          <p:nvPr/>
        </p:nvSpPr>
        <p:spPr>
          <a:xfrm>
            <a:off x="6410181" y="3422129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MBC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5FB5E0D-C255-0CEB-9759-4C698A46F843}"/>
              </a:ext>
            </a:extLst>
          </p:cNvPr>
          <p:cNvSpPr txBox="1"/>
          <p:nvPr/>
        </p:nvSpPr>
        <p:spPr>
          <a:xfrm>
            <a:off x="6877230" y="3416369"/>
            <a:ext cx="534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-26</a:t>
            </a:r>
          </a:p>
        </p:txBody>
      </p:sp>
    </p:spTree>
    <p:extLst>
      <p:ext uri="{BB962C8B-B14F-4D97-AF65-F5344CB8AC3E}">
        <p14:creationId xmlns:p14="http://schemas.microsoft.com/office/powerpoint/2010/main" val="2243876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7</TotalTime>
  <Words>81</Words>
  <Application>Microsoft Macintosh PowerPoint</Application>
  <PresentationFormat>Widescreen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 Narrow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zalez-Juarbe, Norberto</dc:creator>
  <cp:lastModifiedBy>Gonzalez-Juarbe, Norberto</cp:lastModifiedBy>
  <cp:revision>4</cp:revision>
  <dcterms:created xsi:type="dcterms:W3CDTF">2023-11-27T22:34:03Z</dcterms:created>
  <dcterms:modified xsi:type="dcterms:W3CDTF">2024-09-24T21:45:25Z</dcterms:modified>
</cp:coreProperties>
</file>